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12192000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5" autoAdjust="0"/>
    <p:restoredTop sz="94660"/>
  </p:normalViewPr>
  <p:slideViewPr>
    <p:cSldViewPr snapToGrid="0" showGuides="1">
      <p:cViewPr varScale="1">
        <p:scale>
          <a:sx n="93" d="100"/>
          <a:sy n="93" d="100"/>
        </p:scale>
        <p:origin x="504" y="68"/>
      </p:cViewPr>
      <p:guideLst>
        <p:guide orient="horz" pos="249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296173"/>
            <a:ext cx="10363200" cy="2757347"/>
          </a:xfrm>
        </p:spPr>
        <p:txBody>
          <a:bodyPr anchor="b"/>
          <a:lstStyle>
            <a:lvl1pPr algn="ctr"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159854"/>
            <a:ext cx="9144000" cy="1912175"/>
          </a:xfrm>
        </p:spPr>
        <p:txBody>
          <a:bodyPr/>
          <a:lstStyle>
            <a:lvl1pPr marL="0" indent="0" algn="ctr">
              <a:buNone/>
              <a:defRPr sz="2772"/>
            </a:lvl1pPr>
            <a:lvl2pPr marL="528020" indent="0" algn="ctr">
              <a:buNone/>
              <a:defRPr sz="2310"/>
            </a:lvl2pPr>
            <a:lvl3pPr marL="1056041" indent="0" algn="ctr">
              <a:buNone/>
              <a:defRPr sz="2079"/>
            </a:lvl3pPr>
            <a:lvl4pPr marL="1584061" indent="0" algn="ctr">
              <a:buNone/>
              <a:defRPr sz="1848"/>
            </a:lvl4pPr>
            <a:lvl5pPr marL="2112081" indent="0" algn="ctr">
              <a:buNone/>
              <a:defRPr sz="1848"/>
            </a:lvl5pPr>
            <a:lvl6pPr marL="2640101" indent="0" algn="ctr">
              <a:buNone/>
              <a:defRPr sz="1848"/>
            </a:lvl6pPr>
            <a:lvl7pPr marL="3168122" indent="0" algn="ctr">
              <a:buNone/>
              <a:defRPr sz="1848"/>
            </a:lvl7pPr>
            <a:lvl8pPr marL="3696142" indent="0" algn="ctr">
              <a:buNone/>
              <a:defRPr sz="1848"/>
            </a:lvl8pPr>
            <a:lvl9pPr marL="4224162" indent="0" algn="ctr">
              <a:buNone/>
              <a:defRPr sz="184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252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3227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21669"/>
            <a:ext cx="2628900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21669"/>
            <a:ext cx="7734300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3779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6590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974512"/>
            <a:ext cx="10515600" cy="3294515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300194"/>
            <a:ext cx="10515600" cy="1732508"/>
          </a:xfrm>
        </p:spPr>
        <p:txBody>
          <a:bodyPr/>
          <a:lstStyle>
            <a:lvl1pPr marL="0" indent="0">
              <a:buNone/>
              <a:defRPr sz="2772">
                <a:solidFill>
                  <a:schemeClr val="tx1"/>
                </a:solidFill>
              </a:defRPr>
            </a:lvl1pPr>
            <a:lvl2pPr marL="52802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2pPr>
            <a:lvl3pPr marL="1056041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3pPr>
            <a:lvl4pPr marL="158406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4pPr>
            <a:lvl5pPr marL="211208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5pPr>
            <a:lvl6pPr marL="264010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6pPr>
            <a:lvl7pPr marL="316812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7pPr>
            <a:lvl8pPr marL="369614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8pPr>
            <a:lvl9pPr marL="422416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9444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08344"/>
            <a:ext cx="518160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08344"/>
            <a:ext cx="518160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692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21671"/>
            <a:ext cx="10515600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41510"/>
            <a:ext cx="5157787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93014"/>
            <a:ext cx="515778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41510"/>
            <a:ext cx="5183188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93014"/>
            <a:ext cx="518318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370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9024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7128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40341"/>
            <a:ext cx="6172200" cy="5628360"/>
          </a:xfrm>
        </p:spPr>
        <p:txBody>
          <a:bodyPr/>
          <a:lstStyle>
            <a:lvl1pPr>
              <a:defRPr sz="3696"/>
            </a:lvl1pPr>
            <a:lvl2pPr>
              <a:defRPr sz="3234"/>
            </a:lvl2pPr>
            <a:lvl3pPr>
              <a:defRPr sz="2772"/>
            </a:lvl3pPr>
            <a:lvl4pPr>
              <a:defRPr sz="2310"/>
            </a:lvl4pPr>
            <a:lvl5pPr>
              <a:defRPr sz="2310"/>
            </a:lvl5pPr>
            <a:lvl6pPr>
              <a:defRPr sz="2310"/>
            </a:lvl6pPr>
            <a:lvl7pPr>
              <a:defRPr sz="2310"/>
            </a:lvl7pPr>
            <a:lvl8pPr>
              <a:defRPr sz="2310"/>
            </a:lvl8pPr>
            <a:lvl9pPr>
              <a:defRPr sz="231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996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40341"/>
            <a:ext cx="6172200" cy="5628360"/>
          </a:xfrm>
        </p:spPr>
        <p:txBody>
          <a:bodyPr anchor="t"/>
          <a:lstStyle>
            <a:lvl1pPr marL="0" indent="0">
              <a:buNone/>
              <a:defRPr sz="3696"/>
            </a:lvl1pPr>
            <a:lvl2pPr marL="528020" indent="0">
              <a:buNone/>
              <a:defRPr sz="3234"/>
            </a:lvl2pPr>
            <a:lvl3pPr marL="1056041" indent="0">
              <a:buNone/>
              <a:defRPr sz="2772"/>
            </a:lvl3pPr>
            <a:lvl4pPr marL="1584061" indent="0">
              <a:buNone/>
              <a:defRPr sz="2310"/>
            </a:lvl4pPr>
            <a:lvl5pPr marL="2112081" indent="0">
              <a:buNone/>
              <a:defRPr sz="2310"/>
            </a:lvl5pPr>
            <a:lvl6pPr marL="2640101" indent="0">
              <a:buNone/>
              <a:defRPr sz="2310"/>
            </a:lvl6pPr>
            <a:lvl7pPr marL="3168122" indent="0">
              <a:buNone/>
              <a:defRPr sz="2310"/>
            </a:lvl7pPr>
            <a:lvl8pPr marL="3696142" indent="0">
              <a:buNone/>
              <a:defRPr sz="2310"/>
            </a:lvl8pPr>
            <a:lvl9pPr marL="4224162" indent="0">
              <a:buNone/>
              <a:defRPr sz="231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0029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21671"/>
            <a:ext cx="10515600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08344"/>
            <a:ext cx="10515600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7E411-CB3B-4FC2-AC08-5AC2D174D0F3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340703"/>
            <a:ext cx="41148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89EEA-898B-4B17-AF53-87B3A3C80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7802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56041" rtl="0" eaLnBrk="1" latinLnBrk="0" hangingPunct="1">
        <a:lnSpc>
          <a:spcPct val="90000"/>
        </a:lnSpc>
        <a:spcBef>
          <a:spcPct val="0"/>
        </a:spcBef>
        <a:buNone/>
        <a:defRPr sz="50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4010" indent="-264010" algn="l" defTabSz="1056041" rtl="0" eaLnBrk="1" latinLnBrk="0" hangingPunct="1">
        <a:lnSpc>
          <a:spcPct val="90000"/>
        </a:lnSpc>
        <a:spcBef>
          <a:spcPts val="1155"/>
        </a:spcBef>
        <a:buFont typeface="Arial" panose="020B0604020202020204" pitchFamily="34" charset="0"/>
        <a:buChar char="•"/>
        <a:defRPr sz="3234" kern="1200">
          <a:solidFill>
            <a:schemeClr val="tx1"/>
          </a:solidFill>
          <a:latin typeface="+mn-lt"/>
          <a:ea typeface="+mn-ea"/>
          <a:cs typeface="+mn-cs"/>
        </a:defRPr>
      </a:lvl1pPr>
      <a:lvl2pPr marL="792030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772" kern="1200">
          <a:solidFill>
            <a:schemeClr val="tx1"/>
          </a:solidFill>
          <a:latin typeface="+mn-lt"/>
          <a:ea typeface="+mn-ea"/>
          <a:cs typeface="+mn-cs"/>
        </a:defRPr>
      </a:lvl2pPr>
      <a:lvl3pPr marL="132005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3pPr>
      <a:lvl4pPr marL="184807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37609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90411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43213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96015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48817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1pPr>
      <a:lvl2pPr marL="528020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105604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3pPr>
      <a:lvl4pPr marL="158406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11208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64010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16812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69614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22416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BCD8738A-BF1D-1778-63B1-B6C3ADF6937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299" t="21773" r="58666" b="18199"/>
          <a:stretch>
            <a:fillRect/>
          </a:stretch>
        </p:blipFill>
        <p:spPr>
          <a:xfrm>
            <a:off x="7652998" y="564668"/>
            <a:ext cx="1409144" cy="30800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19576DE-A448-8C60-BC43-3C9ED385CE1B}"/>
              </a:ext>
            </a:extLst>
          </p:cNvPr>
          <p:cNvSpPr txBox="1"/>
          <p:nvPr/>
        </p:nvSpPr>
        <p:spPr>
          <a:xfrm>
            <a:off x="6615768" y="1202376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63790A50-66DF-27DC-0861-97C22CF02AC0}"/>
              </a:ext>
            </a:extLst>
          </p:cNvPr>
          <p:cNvSpPr/>
          <p:nvPr/>
        </p:nvSpPr>
        <p:spPr>
          <a:xfrm>
            <a:off x="7433274" y="1202376"/>
            <a:ext cx="193567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E98CEF8-F0CB-7E9C-2A26-ECED4F1F141C}"/>
              </a:ext>
            </a:extLst>
          </p:cNvPr>
          <p:cNvSpPr txBox="1"/>
          <p:nvPr/>
        </p:nvSpPr>
        <p:spPr>
          <a:xfrm>
            <a:off x="7652999" y="254246"/>
            <a:ext cx="14290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75 100</a:t>
            </a:r>
            <a:endParaRPr lang="zh-CN" altLang="en-US" sz="14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2A15CBC-2107-7CBE-16B3-4A631C8B97C5}"/>
              </a:ext>
            </a:extLst>
          </p:cNvPr>
          <p:cNvSpPr txBox="1"/>
          <p:nvPr/>
        </p:nvSpPr>
        <p:spPr>
          <a:xfrm>
            <a:off x="6968142" y="254246"/>
            <a:ext cx="7258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1D62799-D317-5FAB-6D98-170C09339EC4}"/>
              </a:ext>
            </a:extLst>
          </p:cNvPr>
          <p:cNvSpPr txBox="1"/>
          <p:nvPr/>
        </p:nvSpPr>
        <p:spPr>
          <a:xfrm>
            <a:off x="1606040" y="1209566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D678E5E3-2E61-CAF7-B2B5-D5D58A9C490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89" t="16860" r="44322" b="36643"/>
          <a:stretch>
            <a:fillRect/>
          </a:stretch>
        </p:blipFill>
        <p:spPr>
          <a:xfrm rot="21343526">
            <a:off x="2732116" y="491532"/>
            <a:ext cx="2289368" cy="3286229"/>
          </a:xfrm>
          <a:custGeom>
            <a:avLst/>
            <a:gdLst>
              <a:gd name="connsiteX0" fmla="*/ 240815 w 2354591"/>
              <a:gd name="connsiteY0" fmla="*/ 0 h 3379852"/>
              <a:gd name="connsiteX1" fmla="*/ 2354591 w 2354591"/>
              <a:gd name="connsiteY1" fmla="*/ 157992 h 3379852"/>
              <a:gd name="connsiteX2" fmla="*/ 2113777 w 2354591"/>
              <a:gd name="connsiteY2" fmla="*/ 3379852 h 3379852"/>
              <a:gd name="connsiteX3" fmla="*/ 0 w 2354591"/>
              <a:gd name="connsiteY3" fmla="*/ 3221860 h 33798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354591" h="3379852">
                <a:moveTo>
                  <a:pt x="240815" y="0"/>
                </a:moveTo>
                <a:lnTo>
                  <a:pt x="2354591" y="157992"/>
                </a:lnTo>
                <a:lnTo>
                  <a:pt x="2113777" y="3379852"/>
                </a:lnTo>
                <a:lnTo>
                  <a:pt x="0" y="3221860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5676F144-B3D3-80E2-7907-21D11E032235}"/>
              </a:ext>
            </a:extLst>
          </p:cNvPr>
          <p:cNvSpPr/>
          <p:nvPr/>
        </p:nvSpPr>
        <p:spPr>
          <a:xfrm>
            <a:off x="2675675" y="1209566"/>
            <a:ext cx="2374911" cy="33755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0EDD052-A431-FC53-0C43-745C97EC3AAF}"/>
              </a:ext>
            </a:extLst>
          </p:cNvPr>
          <p:cNvSpPr txBox="1"/>
          <p:nvPr/>
        </p:nvSpPr>
        <p:spPr>
          <a:xfrm>
            <a:off x="2749468" y="256892"/>
            <a:ext cx="2301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DMSO     50      75      100</a:t>
            </a:r>
            <a:endParaRPr lang="zh-CN" altLang="en-US" sz="14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A56E0C8-EE23-D1B8-2D0E-E3DBBB4925DF}"/>
              </a:ext>
            </a:extLst>
          </p:cNvPr>
          <p:cNvSpPr txBox="1"/>
          <p:nvPr/>
        </p:nvSpPr>
        <p:spPr>
          <a:xfrm>
            <a:off x="2013294" y="256891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AABD31C5-FDFB-22A8-28F5-585E16637B2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77" t="29786" r="55636" b="24429"/>
          <a:stretch>
            <a:fillRect/>
          </a:stretch>
        </p:blipFill>
        <p:spPr>
          <a:xfrm flipH="1">
            <a:off x="2880733" y="4503408"/>
            <a:ext cx="1964794" cy="326745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E74BB075-60CB-8D7C-A514-9C2BE3C2963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11" t="25805" r="58135" b="29442"/>
          <a:stretch>
            <a:fillRect/>
          </a:stretch>
        </p:blipFill>
        <p:spPr>
          <a:xfrm>
            <a:off x="7271270" y="4503408"/>
            <a:ext cx="2079657" cy="326745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66111FA3-0A4C-6C44-A5CD-877C7582F5A5}"/>
              </a:ext>
            </a:extLst>
          </p:cNvPr>
          <p:cNvSpPr txBox="1"/>
          <p:nvPr/>
        </p:nvSpPr>
        <p:spPr>
          <a:xfrm>
            <a:off x="1581671" y="5187090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A3B74194-94CF-D856-4712-733537AE5CBC}"/>
              </a:ext>
            </a:extLst>
          </p:cNvPr>
          <p:cNvSpPr/>
          <p:nvPr/>
        </p:nvSpPr>
        <p:spPr>
          <a:xfrm>
            <a:off x="2623386" y="5137392"/>
            <a:ext cx="2374911" cy="4081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8D58A86-AEA4-6442-8146-80AD960BDF94}"/>
              </a:ext>
            </a:extLst>
          </p:cNvPr>
          <p:cNvSpPr txBox="1"/>
          <p:nvPr/>
        </p:nvSpPr>
        <p:spPr>
          <a:xfrm>
            <a:off x="2690199" y="4206496"/>
            <a:ext cx="23204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DMSO   50      75      100</a:t>
            </a:r>
            <a:endParaRPr lang="zh-CN" altLang="en-US" sz="14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F5E2304-2DA1-923D-095F-7B0FA6171469}"/>
              </a:ext>
            </a:extLst>
          </p:cNvPr>
          <p:cNvSpPr txBox="1"/>
          <p:nvPr/>
        </p:nvSpPr>
        <p:spPr>
          <a:xfrm>
            <a:off x="1961005" y="4206495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4AB19CC-2C0E-501E-3FEA-0C45F38CAD8F}"/>
              </a:ext>
            </a:extLst>
          </p:cNvPr>
          <p:cNvSpPr txBox="1"/>
          <p:nvPr/>
        </p:nvSpPr>
        <p:spPr>
          <a:xfrm>
            <a:off x="6406694" y="4832124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4D8E436E-A116-BE3F-41FF-FEDC795E6DED}"/>
              </a:ext>
            </a:extLst>
          </p:cNvPr>
          <p:cNvSpPr/>
          <p:nvPr/>
        </p:nvSpPr>
        <p:spPr>
          <a:xfrm>
            <a:off x="7132036" y="4810348"/>
            <a:ext cx="2374911" cy="4081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3C4C827A-305A-5360-93B4-3AAE2FD40754}"/>
              </a:ext>
            </a:extLst>
          </p:cNvPr>
          <p:cNvSpPr txBox="1"/>
          <p:nvPr/>
        </p:nvSpPr>
        <p:spPr>
          <a:xfrm>
            <a:off x="7341935" y="4196050"/>
            <a:ext cx="23204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DMSO   50      75      100</a:t>
            </a:r>
            <a:endParaRPr lang="zh-CN" altLang="en-US" sz="14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2A79DE4-D4A2-B7C9-6591-1AED61D61F2C}"/>
              </a:ext>
            </a:extLst>
          </p:cNvPr>
          <p:cNvSpPr txBox="1"/>
          <p:nvPr/>
        </p:nvSpPr>
        <p:spPr>
          <a:xfrm>
            <a:off x="6452201" y="4196049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7662880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839121E-B9E8-4506-2680-8DBFE2131B3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8344" t="21187" r="49223" b="16749"/>
          <a:stretch>
            <a:fillRect/>
          </a:stretch>
        </p:blipFill>
        <p:spPr>
          <a:xfrm flipH="1">
            <a:off x="3215434" y="532869"/>
            <a:ext cx="1387532" cy="30800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180166F-A95D-260D-7F4E-A36A541984A4}"/>
              </a:ext>
            </a:extLst>
          </p:cNvPr>
          <p:cNvSpPr txBox="1"/>
          <p:nvPr/>
        </p:nvSpPr>
        <p:spPr>
          <a:xfrm>
            <a:off x="2291553" y="1539909"/>
            <a:ext cx="916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FI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00CAA10-92D0-073E-7752-7F4F14F9EA0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7574" t="21284" r="50153" b="21937"/>
          <a:stretch>
            <a:fillRect/>
          </a:stretch>
        </p:blipFill>
        <p:spPr>
          <a:xfrm>
            <a:off x="5347138" y="4549328"/>
            <a:ext cx="1543529" cy="3156848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1579EC95-1DB0-1FCC-C9C6-C0AEE07514AC}"/>
              </a:ext>
            </a:extLst>
          </p:cNvPr>
          <p:cNvSpPr txBox="1"/>
          <p:nvPr/>
        </p:nvSpPr>
        <p:spPr>
          <a:xfrm>
            <a:off x="3709560" y="5754860"/>
            <a:ext cx="160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ta 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9AD971C-E97A-8BAD-FF01-41A4FDEFA95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2555" t="21088" r="64827" b="23459"/>
          <a:stretch>
            <a:fillRect/>
          </a:stretch>
        </p:blipFill>
        <p:spPr>
          <a:xfrm>
            <a:off x="7314028" y="531546"/>
            <a:ext cx="1603897" cy="315501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5F510AEF-0B9C-67BE-0BF5-7D7FEE893A8C}"/>
              </a:ext>
            </a:extLst>
          </p:cNvPr>
          <p:cNvSpPr txBox="1"/>
          <p:nvPr/>
        </p:nvSpPr>
        <p:spPr>
          <a:xfrm>
            <a:off x="6356990" y="1520582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AS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8DFAF940-92FB-3248-C87D-2225844A7891}"/>
              </a:ext>
            </a:extLst>
          </p:cNvPr>
          <p:cNvSpPr/>
          <p:nvPr/>
        </p:nvSpPr>
        <p:spPr>
          <a:xfrm>
            <a:off x="2976121" y="1539909"/>
            <a:ext cx="193567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4993DE0-BBF6-D321-8963-670D3ED7FA93}"/>
              </a:ext>
            </a:extLst>
          </p:cNvPr>
          <p:cNvSpPr/>
          <p:nvPr/>
        </p:nvSpPr>
        <p:spPr>
          <a:xfrm>
            <a:off x="7148132" y="1577364"/>
            <a:ext cx="1935678" cy="2557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AA2D27AB-5084-FBB4-65BC-27211D041D68}"/>
              </a:ext>
            </a:extLst>
          </p:cNvPr>
          <p:cNvSpPr/>
          <p:nvPr/>
        </p:nvSpPr>
        <p:spPr>
          <a:xfrm>
            <a:off x="5212454" y="5757505"/>
            <a:ext cx="193567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046BDBA-D2DF-47AD-B4F7-F8047F46BF80}"/>
              </a:ext>
            </a:extLst>
          </p:cNvPr>
          <p:cNvSpPr txBox="1"/>
          <p:nvPr/>
        </p:nvSpPr>
        <p:spPr>
          <a:xfrm>
            <a:off x="3173938" y="223769"/>
            <a:ext cx="14290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75 100</a:t>
            </a:r>
            <a:endParaRPr lang="zh-CN" altLang="en-US" sz="14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E77AAD4-F915-77F0-6E7E-81935246254E}"/>
              </a:ext>
            </a:extLst>
          </p:cNvPr>
          <p:cNvSpPr txBox="1"/>
          <p:nvPr/>
        </p:nvSpPr>
        <p:spPr>
          <a:xfrm>
            <a:off x="2489081" y="223769"/>
            <a:ext cx="7258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6FD7B89-503E-CE5B-EB47-9A2B25B53895}"/>
              </a:ext>
            </a:extLst>
          </p:cNvPr>
          <p:cNvSpPr txBox="1"/>
          <p:nvPr/>
        </p:nvSpPr>
        <p:spPr>
          <a:xfrm>
            <a:off x="7488887" y="223769"/>
            <a:ext cx="14290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75 100</a:t>
            </a:r>
            <a:endParaRPr lang="zh-CN" altLang="en-US" sz="14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1BA218F-6C91-1501-A654-7ED32E08B5E8}"/>
              </a:ext>
            </a:extLst>
          </p:cNvPr>
          <p:cNvSpPr txBox="1"/>
          <p:nvPr/>
        </p:nvSpPr>
        <p:spPr>
          <a:xfrm>
            <a:off x="6804030" y="223769"/>
            <a:ext cx="7258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65A593A-D238-9CD4-53F6-8B6BE4B90E38}"/>
              </a:ext>
            </a:extLst>
          </p:cNvPr>
          <p:cNvSpPr txBox="1"/>
          <p:nvPr/>
        </p:nvSpPr>
        <p:spPr>
          <a:xfrm>
            <a:off x="5380954" y="4234651"/>
            <a:ext cx="16038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 75   100</a:t>
            </a:r>
            <a:endParaRPr lang="zh-CN" altLang="en-US" sz="14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26BC39D-0EA1-973A-B236-EEB58217A44F}"/>
              </a:ext>
            </a:extLst>
          </p:cNvPr>
          <p:cNvSpPr txBox="1"/>
          <p:nvPr/>
        </p:nvSpPr>
        <p:spPr>
          <a:xfrm>
            <a:off x="4721498" y="4234651"/>
            <a:ext cx="7258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781117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</TotalTime>
  <Words>67</Words>
  <Application>Microsoft Office PowerPoint</Application>
  <PresentationFormat>自定义</PresentationFormat>
  <Paragraphs>2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星宇 陈</dc:creator>
  <cp:lastModifiedBy>星宇 陈</cp:lastModifiedBy>
  <cp:revision>3</cp:revision>
  <dcterms:created xsi:type="dcterms:W3CDTF">2025-08-14T13:01:03Z</dcterms:created>
  <dcterms:modified xsi:type="dcterms:W3CDTF">2025-09-11T10:27:22Z</dcterms:modified>
</cp:coreProperties>
</file>